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85" r:id="rId2"/>
    <p:sldId id="271" r:id="rId3"/>
    <p:sldId id="274" r:id="rId4"/>
    <p:sldId id="272" r:id="rId5"/>
    <p:sldId id="284" r:id="rId6"/>
    <p:sldId id="258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A58A23E-57A9-B9E9-FAC6-2CBC818C3B30}" name="Altwerger, Gary [BSD]" initials="AG[" userId="S::altwerger@uchicagomedicine.org::862117ff-abd9-4b36-bb88-4d4ff69b937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599"/>
    <p:restoredTop sz="94708"/>
  </p:normalViewPr>
  <p:slideViewPr>
    <p:cSldViewPr snapToGrid="0">
      <p:cViewPr varScale="1">
        <p:scale>
          <a:sx n="118" d="100"/>
          <a:sy n="118" d="100"/>
        </p:scale>
        <p:origin x="80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B61189-1559-2E49-8E37-57CBDAAF677B}" type="datetimeFigureOut">
              <a:rPr lang="en-US" smtClean="0"/>
              <a:t>4/25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B974F2-7CC7-1041-91AE-BD3D3AE5F3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3114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CFA202-DACE-8F49-A89C-4F1A3369FD3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13415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CFA202-DACE-8F49-A89C-4F1A3369FD3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31522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CFA202-DACE-8F49-A89C-4F1A3369FD3E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5865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EDE0B1-A941-3B02-50BB-FF975C2B83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3EC154A-56CC-9ACA-8FFA-5EC8958D6E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94CAD8-8CF1-B054-A882-E4F804F21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C0DC9-3865-044F-9174-0FAF33CCFF48}" type="datetimeFigureOut">
              <a:rPr lang="en-US" smtClean="0"/>
              <a:t>4/25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8F9E85-0DBF-C477-8036-C43F0D8BC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F46146-E562-8590-A183-3C65429892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3E0AA-35D7-114B-9F3C-60E50DC58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318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828AC1-492F-7824-C8C0-FBCC8FFE7D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4B03FF-1FE7-5BB8-7290-7F5587539A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7EFDE0-BC4C-B26A-683F-A5C259B80A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C0DC9-3865-044F-9174-0FAF33CCFF48}" type="datetimeFigureOut">
              <a:rPr lang="en-US" smtClean="0"/>
              <a:t>4/25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30A707-C221-88BB-C3BE-A316308C4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5A2E87-FF08-2000-E30A-62BE714BF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3E0AA-35D7-114B-9F3C-60E50DC58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2879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528A876-1E0B-9FBC-F48E-00C5BB0FFA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CE3F01-8963-0387-74E4-7A66ECF1E6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1A2A5F-B44F-F822-4167-161149047D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C0DC9-3865-044F-9174-0FAF33CCFF48}" type="datetimeFigureOut">
              <a:rPr lang="en-US" smtClean="0"/>
              <a:t>4/25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28CD32-0AB3-D28D-DBF7-87F62143C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A2C1B9-F638-BF4E-21D7-65921929C7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3E0AA-35D7-114B-9F3C-60E50DC58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1759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AD8C9B-FCF5-BD98-9634-26FF008262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B5AED0-7B2C-F3A4-3858-CFA82862A7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AF6D66-2ADE-4409-4508-CC13993E1C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C0DC9-3865-044F-9174-0FAF33CCFF48}" type="datetimeFigureOut">
              <a:rPr lang="en-US" smtClean="0"/>
              <a:t>4/25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06899D-0672-0CCF-ADE9-D5E3A1B7EC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626073-CAF5-4808-50A1-381753927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3E0AA-35D7-114B-9F3C-60E50DC58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763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75FA80-5097-867C-AAC2-A73CF3A46F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164288-95EC-69BF-3940-40870D7587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C536E4-D62A-60C3-99E5-43684EBF49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C0DC9-3865-044F-9174-0FAF33CCFF48}" type="datetimeFigureOut">
              <a:rPr lang="en-US" smtClean="0"/>
              <a:t>4/25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9854E2-EEEE-54C0-F371-B16E0226D8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984B4B-4E03-37FB-3849-C3182F2AAA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3E0AA-35D7-114B-9F3C-60E50DC58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391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5ADDB7-B159-913C-054D-DDB1910510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DEB303-0513-964A-8F9E-C22C7A9731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B74DB2-DC48-797B-4F28-5C022B4E97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BA5EE8-0D37-6141-5E0D-513F94940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C0DC9-3865-044F-9174-0FAF33CCFF48}" type="datetimeFigureOut">
              <a:rPr lang="en-US" smtClean="0"/>
              <a:t>4/25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620AF4-0F29-F9A1-6ECF-8B723A2C42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2B9969-2441-E300-07D9-FB960EB92D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3E0AA-35D7-114B-9F3C-60E50DC58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431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35CA89-ECE0-E25F-74A8-91C8CB231E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0E547F-A212-D9C7-4AFD-1A3801E8D8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484E7B-925A-E9F0-34F6-5652669D1E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D5DBAB4-911D-9781-13FE-C1014FD8B2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5FF5BF5-8885-E52D-7CF0-15EF27A4E59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AE2F609-7B7E-2672-40FB-3A88408FD4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C0DC9-3865-044F-9174-0FAF33CCFF48}" type="datetimeFigureOut">
              <a:rPr lang="en-US" smtClean="0"/>
              <a:t>4/25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FD63992-B5C4-9611-A5E3-1B42E8CEBB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D60F941-110A-870D-BEF3-CFADA21356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3E0AA-35D7-114B-9F3C-60E50DC58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81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F00D64-3D06-61B3-817B-DC0D43F1EA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B243AB1-34C3-9208-C8FF-953D68D6C0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C0DC9-3865-044F-9174-0FAF33CCFF48}" type="datetimeFigureOut">
              <a:rPr lang="en-US" smtClean="0"/>
              <a:t>4/25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72EE94C-1D03-5D87-34A0-AC0D6D25B1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BA31104-3AFE-CBD3-B000-6522D886A8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3E0AA-35D7-114B-9F3C-60E50DC58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000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63C711-F8B6-D429-6418-E065E60D8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C0DC9-3865-044F-9174-0FAF33CCFF48}" type="datetimeFigureOut">
              <a:rPr lang="en-US" smtClean="0"/>
              <a:t>4/25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F5FF485-D286-2853-E89B-0B187E2B1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E428EC-BF04-6FDA-9144-C6CC3C8EFF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3E0AA-35D7-114B-9F3C-60E50DC58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990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29EA09-E5DC-D499-82CB-8E48E2EC26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F8B86D-1F78-896A-5FBF-EB1A6CDE93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444E4E4-E0FC-2D39-B8AA-A346F999A2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4E0EE0-113C-CA4F-EAED-FF7ABC3A8A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C0DC9-3865-044F-9174-0FAF33CCFF48}" type="datetimeFigureOut">
              <a:rPr lang="en-US" smtClean="0"/>
              <a:t>4/25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5F560C-EDB2-C0F6-7440-6383B47014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5DB8A2-EEB8-FBE0-5B5C-03B5B5889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3E0AA-35D7-114B-9F3C-60E50DC58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367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0AF88B-E34C-69F2-302B-5979BC6569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B03212A-4359-0416-6BB2-0951B91498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CD7ADB-5445-460B-F414-64A1EEBF89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CF46BB-3150-0933-037E-218369DDC8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C0DC9-3865-044F-9174-0FAF33CCFF48}" type="datetimeFigureOut">
              <a:rPr lang="en-US" smtClean="0"/>
              <a:t>4/25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747D48-BA3B-62B0-4690-248AB1FAD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C9A342-DBC5-3415-5FF1-AAB2A7A68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3E0AA-35D7-114B-9F3C-60E50DC58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806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3D45EBA-1958-6574-FA55-4686B7AA0F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BD8813-2D33-1A6D-8C58-E8A023FA16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4722DD-800E-82BD-4667-3A5EBEB14B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DC0DC9-3865-044F-9174-0FAF33CCFF48}" type="datetimeFigureOut">
              <a:rPr lang="en-US" smtClean="0"/>
              <a:t>4/25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E89290-B05C-FA4A-8959-883A2DBE3B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4CD76F-2276-BE76-B15A-2529DBB5B7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FC3E0AA-35D7-114B-9F3C-60E50DC58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220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29E37AD-7D57-3079-479C-EA79A37F1CC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9517101"/>
              </p:ext>
            </p:extLst>
          </p:nvPr>
        </p:nvGraphicFramePr>
        <p:xfrm>
          <a:off x="1200598" y="1148732"/>
          <a:ext cx="9154685" cy="3922028"/>
        </p:xfrm>
        <a:graphic>
          <a:graphicData uri="http://schemas.openxmlformats.org/drawingml/2006/table">
            <a:tbl>
              <a:tblPr/>
              <a:tblGrid>
                <a:gridCol w="3599988">
                  <a:extLst>
                    <a:ext uri="{9D8B030D-6E8A-4147-A177-3AD203B41FA5}">
                      <a16:colId xmlns:a16="http://schemas.microsoft.com/office/drawing/2014/main" val="2007395793"/>
                    </a:ext>
                  </a:extLst>
                </a:gridCol>
                <a:gridCol w="2799622">
                  <a:extLst>
                    <a:ext uri="{9D8B030D-6E8A-4147-A177-3AD203B41FA5}">
                      <a16:colId xmlns:a16="http://schemas.microsoft.com/office/drawing/2014/main" val="3359998664"/>
                    </a:ext>
                  </a:extLst>
                </a:gridCol>
                <a:gridCol w="2755075">
                  <a:extLst>
                    <a:ext uri="{9D8B030D-6E8A-4147-A177-3AD203B41FA5}">
                      <a16:colId xmlns:a16="http://schemas.microsoft.com/office/drawing/2014/main" val="221946958"/>
                    </a:ext>
                  </a:extLst>
                </a:gridCol>
              </a:tblGrid>
              <a:tr h="356548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aracteristic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≤10 mg (n = 28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10 mg (n = 31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9079981"/>
                  </a:ext>
                </a:extLst>
              </a:tr>
              <a:tr h="356548">
                <a:tc>
                  <a:txBody>
                    <a:bodyPr/>
                    <a:lstStyle/>
                    <a:p>
                      <a:pPr algn="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an age, years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.5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.0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877899"/>
                  </a:ext>
                </a:extLst>
              </a:tr>
              <a:tr h="356548">
                <a:tc>
                  <a:txBody>
                    <a:bodyPr/>
                    <a:lstStyle/>
                    <a:p>
                      <a:pPr algn="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an BMI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3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5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2748963"/>
                  </a:ext>
                </a:extLst>
              </a:tr>
              <a:tr h="356548">
                <a:tc>
                  <a:txBody>
                    <a:bodyPr/>
                    <a:lstStyle/>
                    <a:p>
                      <a:pPr algn="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an number of prior systemic regimens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5177708"/>
                  </a:ext>
                </a:extLst>
              </a:tr>
              <a:tr h="356548">
                <a:tc>
                  <a:txBody>
                    <a:bodyPr/>
                    <a:lstStyle/>
                    <a:p>
                      <a:pPr algn="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COG performance status 0–1, n (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 (82.1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 (90.3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7882753"/>
                  </a:ext>
                </a:extLst>
              </a:tr>
              <a:tr h="356548">
                <a:tc>
                  <a:txBody>
                    <a:bodyPr/>
                    <a:lstStyle/>
                    <a:p>
                      <a:pPr algn="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COG performance status ≥2, n (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(17.9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 (9.7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112210"/>
                  </a:ext>
                </a:extLst>
              </a:tr>
              <a:tr h="356548">
                <a:tc>
                  <a:txBody>
                    <a:bodyPr/>
                    <a:lstStyle/>
                    <a:p>
                      <a:pPr algn="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-grade histology, n (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 (96.4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 (61.3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1100534"/>
                  </a:ext>
                </a:extLst>
              </a:tr>
              <a:tr h="356548">
                <a:tc>
                  <a:txBody>
                    <a:bodyPr/>
                    <a:lstStyle/>
                    <a:p>
                      <a:pPr algn="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tinum-resistant disease, n (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 (60.7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 (87.1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0214773"/>
                  </a:ext>
                </a:extLst>
              </a:tr>
              <a:tr h="356548">
                <a:tc>
                  <a:txBody>
                    <a:bodyPr/>
                    <a:lstStyle/>
                    <a:p>
                      <a:pPr algn="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tinum-sensitive disease, n (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 (39.3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(12.9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6875355"/>
                  </a:ext>
                </a:extLst>
              </a:tr>
              <a:tr h="356548">
                <a:tc>
                  <a:txBody>
                    <a:bodyPr/>
                    <a:lstStyle/>
                    <a:p>
                      <a:pPr algn="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53-mutated tumors, n (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 (71.4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 (64.5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4299032"/>
                  </a:ext>
                </a:extLst>
              </a:tr>
              <a:tr h="356548">
                <a:tc>
                  <a:txBody>
                    <a:bodyPr/>
                    <a:lstStyle/>
                    <a:p>
                      <a:pPr algn="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smatch repair–proficient tumors, n (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25 (89.3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 (87.1%)</a:t>
                      </a:r>
                    </a:p>
                  </a:txBody>
                  <a:tcPr marL="77702" marR="77702" marT="38851" marB="38851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5636654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012D5126-2A7F-31D4-8CC0-F8AE10A8999F}"/>
              </a:ext>
            </a:extLst>
          </p:cNvPr>
          <p:cNvSpPr txBox="1"/>
          <p:nvPr/>
        </p:nvSpPr>
        <p:spPr>
          <a:xfrm>
            <a:off x="246185" y="365125"/>
            <a:ext cx="77497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Baseline clinical characteristics by lenvatinib starting dose*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347FC6D-91EB-5265-3909-57AF8149E4D3}"/>
              </a:ext>
            </a:extLst>
          </p:cNvPr>
          <p:cNvSpPr txBox="1"/>
          <p:nvPr/>
        </p:nvSpPr>
        <p:spPr>
          <a:xfrm>
            <a:off x="1066800" y="5196827"/>
            <a:ext cx="10058400" cy="538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Dose comparisons in this table reflect binary stratification of lenvatinib starting dose (≤10 mg vs &gt;10 mg).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MMR status unknown for 1 patient in ≤10 mg group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670789E-D6B8-1356-D477-11576A334F2E}"/>
              </a:ext>
            </a:extLst>
          </p:cNvPr>
          <p:cNvSpPr txBox="1"/>
          <p:nvPr/>
        </p:nvSpPr>
        <p:spPr>
          <a:xfrm>
            <a:off x="1128478" y="5837753"/>
            <a:ext cx="88467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Baseline clinical and pathologic characteristics stratified by binary lenvatinib starting dose group (≤10 mg vs &gt;10 mg).</a:t>
            </a:r>
          </a:p>
        </p:txBody>
      </p:sp>
    </p:spTree>
    <p:extLst>
      <p:ext uri="{BB962C8B-B14F-4D97-AF65-F5344CB8AC3E}">
        <p14:creationId xmlns:p14="http://schemas.microsoft.com/office/powerpoint/2010/main" val="27651389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F4386347-7935-120F-79FF-AA147AF9B8B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4322628"/>
              </p:ext>
            </p:extLst>
          </p:nvPr>
        </p:nvGraphicFramePr>
        <p:xfrm>
          <a:off x="838200" y="1073171"/>
          <a:ext cx="10515600" cy="416114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093202">
                  <a:extLst>
                    <a:ext uri="{9D8B030D-6E8A-4147-A177-3AD203B41FA5}">
                      <a16:colId xmlns:a16="http://schemas.microsoft.com/office/drawing/2014/main" val="1068746188"/>
                    </a:ext>
                  </a:extLst>
                </a:gridCol>
                <a:gridCol w="624149">
                  <a:extLst>
                    <a:ext uri="{9D8B030D-6E8A-4147-A177-3AD203B41FA5}">
                      <a16:colId xmlns:a16="http://schemas.microsoft.com/office/drawing/2014/main" val="4285608408"/>
                    </a:ext>
                  </a:extLst>
                </a:gridCol>
                <a:gridCol w="1358678">
                  <a:extLst>
                    <a:ext uri="{9D8B030D-6E8A-4147-A177-3AD203B41FA5}">
                      <a16:colId xmlns:a16="http://schemas.microsoft.com/office/drawing/2014/main" val="3315077982"/>
                    </a:ext>
                  </a:extLst>
                </a:gridCol>
                <a:gridCol w="1506579">
                  <a:extLst>
                    <a:ext uri="{9D8B030D-6E8A-4147-A177-3AD203B41FA5}">
                      <a16:colId xmlns:a16="http://schemas.microsoft.com/office/drawing/2014/main" val="1040059357"/>
                    </a:ext>
                  </a:extLst>
                </a:gridCol>
                <a:gridCol w="1380426">
                  <a:extLst>
                    <a:ext uri="{9D8B030D-6E8A-4147-A177-3AD203B41FA5}">
                      <a16:colId xmlns:a16="http://schemas.microsoft.com/office/drawing/2014/main" val="2580614746"/>
                    </a:ext>
                  </a:extLst>
                </a:gridCol>
                <a:gridCol w="1542830">
                  <a:extLst>
                    <a:ext uri="{9D8B030D-6E8A-4147-A177-3AD203B41FA5}">
                      <a16:colId xmlns:a16="http://schemas.microsoft.com/office/drawing/2014/main" val="2032609202"/>
                    </a:ext>
                  </a:extLst>
                </a:gridCol>
                <a:gridCol w="1004868">
                  <a:extLst>
                    <a:ext uri="{9D8B030D-6E8A-4147-A177-3AD203B41FA5}">
                      <a16:colId xmlns:a16="http://schemas.microsoft.com/office/drawing/2014/main" val="747354801"/>
                    </a:ext>
                  </a:extLst>
                </a:gridCol>
                <a:gridCol w="1004868">
                  <a:extLst>
                    <a:ext uri="{9D8B030D-6E8A-4147-A177-3AD203B41FA5}">
                      <a16:colId xmlns:a16="http://schemas.microsoft.com/office/drawing/2014/main" val="773658308"/>
                    </a:ext>
                  </a:extLst>
                </a:gridCol>
              </a:tblGrid>
              <a:tr h="698416">
                <a:tc>
                  <a:txBody>
                    <a:bodyPr/>
                    <a:lstStyle/>
                    <a:p>
                      <a:pPr algn="l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tial Response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lete Response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ble Disease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gressive Disease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R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58834305"/>
                  </a:ext>
                </a:extLst>
              </a:tr>
              <a:tr h="414937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erall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%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16017852"/>
                  </a:ext>
                </a:extLst>
              </a:tr>
              <a:tr h="352809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vatinib Starting Dose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03860918"/>
                  </a:ext>
                </a:extLst>
              </a:tr>
              <a:tr h="414937"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mg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46115364"/>
                  </a:ext>
                </a:extLst>
              </a:tr>
              <a:tr h="414937"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 mg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69384206"/>
                  </a:ext>
                </a:extLst>
              </a:tr>
              <a:tr h="414937"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mg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.4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14719959"/>
                  </a:ext>
                </a:extLst>
              </a:tr>
              <a:tr h="414937"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 mg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3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89356102"/>
                  </a:ext>
                </a:extLst>
              </a:tr>
              <a:tr h="414937"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 mg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6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67435509"/>
                  </a:ext>
                </a:extLst>
              </a:tr>
              <a:tr h="414937">
                <a:tc>
                  <a:txBody>
                    <a:bodyPr/>
                    <a:lstStyle/>
                    <a:p>
                      <a:pPr algn="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 mg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2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42696775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78225698-53B2-27CF-3250-316F1A99EBAA}"/>
              </a:ext>
            </a:extLst>
          </p:cNvPr>
          <p:cNvSpPr txBox="1"/>
          <p:nvPr/>
        </p:nvSpPr>
        <p:spPr>
          <a:xfrm>
            <a:off x="246185" y="365125"/>
            <a:ext cx="54718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ORR based on lenvatinib starting dos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250E8C1-91F8-BD1E-F1D5-5D7400505564}"/>
              </a:ext>
            </a:extLst>
          </p:cNvPr>
          <p:cNvSpPr txBox="1"/>
          <p:nvPr/>
        </p:nvSpPr>
        <p:spPr>
          <a:xfrm>
            <a:off x="838200" y="5630940"/>
            <a:ext cx="57216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Objective response rate according to exact lenvatinib starting dose.</a:t>
            </a:r>
          </a:p>
        </p:txBody>
      </p:sp>
    </p:spTree>
    <p:extLst>
      <p:ext uri="{BB962C8B-B14F-4D97-AF65-F5344CB8AC3E}">
        <p14:creationId xmlns:p14="http://schemas.microsoft.com/office/powerpoint/2010/main" val="10675363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sp>
            <p:nvSpPr>
              <p:cNvPr id="2" name="Title 1">
                <a:extLst>
                  <a:ext uri="{FF2B5EF4-FFF2-40B4-BE49-F238E27FC236}">
                    <a16:creationId xmlns:a16="http://schemas.microsoft.com/office/drawing/2014/main" id="{4D9B662E-24C9-5C18-F85E-2F83ECDDC4DA}"/>
                  </a:ext>
                </a:extLst>
              </p:cNvPr>
              <p:cNvSpPr>
                <a:spLocks noGrp="1"/>
              </p:cNvSpPr>
              <p:nvPr>
                <p:ph type="title"/>
              </p:nvPr>
            </p:nvSpPr>
            <p:spPr/>
            <p:txBody>
              <a:bodyPr>
                <a:normAutofit/>
              </a:bodyPr>
              <a:lstStyle/>
              <a:p>
                <a:r>
                  <a: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igure S3: Non-inferiority test between the </a:t>
                </a:r>
                <a14:m>
                  <m:oMath xmlns:m="http://schemas.openxmlformats.org/officeDocument/2006/math">
                    <m:r>
                      <a:rPr lang="en-US" sz="2000" b="1" i="1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≤ </m:t>
                    </m:r>
                    <m:r>
                      <a:rPr lang="en-US" sz="2000" b="1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 </m:t>
                    </m:r>
                  </m:oMath>
                </a14:m>
                <a:r>
                  <a: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 mg and &gt; 10 mg dose groups</a:t>
                </a:r>
              </a:p>
            </p:txBody>
          </p:sp>
        </mc:Choice>
        <mc:Fallback xmlns="">
          <p:sp>
            <p:nvSpPr>
              <p:cNvPr id="2" name="Title 1">
                <a:extLst>
                  <a:ext uri="{FF2B5EF4-FFF2-40B4-BE49-F238E27FC236}">
                    <a16:creationId xmlns:a16="http://schemas.microsoft.com/office/drawing/2014/main" id="{4D9B662E-24C9-5C18-F85E-2F83ECDDC4DA}"/>
                  </a:ext>
                </a:extLst>
              </p:cNvPr>
              <p:cNvSpPr>
                <a:spLocks noGrp="1" noRot="1" noChangeAspect="1" noMove="1" noResize="1" noEditPoints="1" noAdjustHandles="1" noChangeArrowheads="1" noChangeShapeType="1" noTextEdit="1"/>
              </p:cNvSpPr>
              <p:nvPr>
                <p:ph type="title"/>
              </p:nvPr>
            </p:nvSpPr>
            <p:spPr>
              <a:blipFill>
                <a:blip r:embed="rId2"/>
                <a:stretch>
                  <a:fillRect l="-724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2" name="Rectangle 21">
            <a:extLst>
              <a:ext uri="{FF2B5EF4-FFF2-40B4-BE49-F238E27FC236}">
                <a16:creationId xmlns:a16="http://schemas.microsoft.com/office/drawing/2014/main" id="{8659FD95-AC7B-6FEA-1103-55367BAD9003}"/>
              </a:ext>
            </a:extLst>
          </p:cNvPr>
          <p:cNvSpPr/>
          <p:nvPr/>
        </p:nvSpPr>
        <p:spPr>
          <a:xfrm>
            <a:off x="3043434" y="6081814"/>
            <a:ext cx="2345931" cy="410033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8" name="Picture 27" descr="A graph with a blue line and a black box&#10;&#10;AI-generated content may be incorrect.">
            <a:extLst>
              <a:ext uri="{FF2B5EF4-FFF2-40B4-BE49-F238E27FC236}">
                <a16:creationId xmlns:a16="http://schemas.microsoft.com/office/drawing/2014/main" id="{D94A5FFD-7118-DF8C-2851-C423750CE3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18482" y="1961633"/>
            <a:ext cx="7155035" cy="2934733"/>
          </a:xfrm>
          <a:prstGeom prst="rect">
            <a:avLst/>
          </a:prstGeom>
        </p:spPr>
      </p:pic>
      <p:sp>
        <p:nvSpPr>
          <p:cNvPr id="4" name="Rectangle 1">
            <a:extLst>
              <a:ext uri="{FF2B5EF4-FFF2-40B4-BE49-F238E27FC236}">
                <a16:creationId xmlns:a16="http://schemas.microsoft.com/office/drawing/2014/main" id="{6B23AE3F-916B-4380-8D19-AEFA4530FE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3606" y="5285364"/>
            <a:ext cx="10924786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Non-inferiority analysis comparing objective response rate between patients treated with lenvatinib starting doses of ≤10 mg and &gt;10 mg. </a:t>
            </a:r>
            <a:br>
              <a:rPr lang="en-US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30990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5E787CD-1062-7800-CD78-F0EBF566990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ABB5B64-ABFA-A0B2-8E86-E45651FDA3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49974" y="1476927"/>
            <a:ext cx="5024004" cy="3191889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A15571F5-E12C-3903-3545-39181713BE6F}"/>
                  </a:ext>
                </a:extLst>
              </p:cNvPr>
              <p:cNvSpPr txBox="1"/>
              <p:nvPr/>
            </p:nvSpPr>
            <p:spPr>
              <a:xfrm>
                <a:off x="6609094" y="336445"/>
                <a:ext cx="5773515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igure S4b. PFS Lenvatinib Starting Dose </a:t>
                </a:r>
              </a:p>
              <a:p>
                <a:pPr algn="ctr"/>
                <a:r>
                  <a: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14:m>
                  <m:oMath xmlns:m="http://schemas.openxmlformats.org/officeDocument/2006/math">
                    <m:r>
                      <a:rPr lang="en-US" sz="2000" b="1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≤</m:t>
                    </m:r>
                    <m:r>
                      <a:rPr lang="en-US" sz="2000" b="1" i="0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𝟐𝟎</m:t>
                    </m:r>
                  </m:oMath>
                </a14:m>
                <a:r>
                  <a: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g vs. &gt;20 mg)</a:t>
                </a:r>
              </a:p>
            </p:txBody>
          </p:sp>
        </mc:Choice>
        <mc:Fallback xmlns=""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A15571F5-E12C-3903-3545-39181713BE6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6609094" y="336445"/>
                <a:ext cx="5773515" cy="707886"/>
              </a:xfrm>
              <a:prstGeom prst="rect">
                <a:avLst/>
              </a:prstGeom>
              <a:blipFill>
                <a:blip r:embed="rId3"/>
                <a:stretch>
                  <a:fillRect t="-3509" b="-14035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CFD67A02-1536-CBD7-882B-0D0CAFF28049}"/>
                  </a:ext>
                </a:extLst>
              </p:cNvPr>
              <p:cNvSpPr txBox="1"/>
              <p:nvPr/>
            </p:nvSpPr>
            <p:spPr>
              <a:xfrm>
                <a:off x="6418485" y="4842464"/>
                <a:ext cx="5773515" cy="10772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dian OS</a:t>
                </a:r>
              </a:p>
              <a:p>
                <a14:m>
                  <m:oMath xmlns:m="http://schemas.openxmlformats.org/officeDocument/2006/math">
                    <m:r>
                      <a:rPr lang="en-US" sz="16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≤</m:t>
                    </m:r>
                    <m:r>
                      <a:rPr lang="en-US" sz="1600" b="0" i="0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20</m:t>
                    </m:r>
                  </m:oMath>
                </a14:m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g: 3.68 </a:t>
                </a:r>
                <a:r>
                  <a:rPr lang="en-US" sz="1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&gt;20 mg: 2.39 </a:t>
                </a:r>
                <a:r>
                  <a:rPr lang="en-US" sz="1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</a:t>
                </a:r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  <a:p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azard Ratio (</a:t>
                </a:r>
                <a14:m>
                  <m:oMath xmlns:m="http://schemas.openxmlformats.org/officeDocument/2006/math">
                    <m:r>
                      <a:rPr lang="en-US" sz="1600" i="1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≤</m:t>
                    </m:r>
                  </m:oMath>
                </a14:m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0 mg/ &gt;20 mg): 0.8635 (95% CI 0.448 to 1.66)</a:t>
                </a:r>
              </a:p>
            </p:txBody>
          </p:sp>
        </mc:Choice>
        <mc:Fallback xmlns=""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CFD67A02-1536-CBD7-882B-0D0CAFF28049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6418485" y="4842464"/>
                <a:ext cx="5773515" cy="1077218"/>
              </a:xfrm>
              <a:prstGeom prst="rect">
                <a:avLst/>
              </a:prstGeom>
              <a:blipFill>
                <a:blip r:embed="rId4"/>
                <a:stretch>
                  <a:fillRect l="-439" t="-2326" b="-5814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63E2493A-0214-3211-F3D8-AFCB9EA67D08}"/>
                  </a:ext>
                </a:extLst>
              </p:cNvPr>
              <p:cNvSpPr txBox="1"/>
              <p:nvPr/>
            </p:nvSpPr>
            <p:spPr>
              <a:xfrm>
                <a:off x="448518" y="336445"/>
                <a:ext cx="5521448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igure S4a. PFS Lenvatinib Starting Dose </a:t>
                </a:r>
              </a:p>
              <a:p>
                <a:pPr algn="ctr"/>
                <a:r>
                  <a: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14:m>
                  <m:oMath xmlns:m="http://schemas.openxmlformats.org/officeDocument/2006/math">
                    <m:r>
                      <a:rPr lang="en-US" sz="2000" b="1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≤</m:t>
                    </m:r>
                  </m:oMath>
                </a14:m>
                <a:r>
                  <a: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 mg vs. &gt;14 mg)</a:t>
                </a:r>
              </a:p>
            </p:txBody>
          </p:sp>
        </mc:Choice>
        <mc:Fallback xmlns=""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63E2493A-0214-3211-F3D8-AFCB9EA67D08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48518" y="336445"/>
                <a:ext cx="5521448" cy="707886"/>
              </a:xfrm>
              <a:prstGeom prst="rect">
                <a:avLst/>
              </a:prstGeom>
              <a:blipFill>
                <a:blip r:embed="rId5"/>
                <a:stretch>
                  <a:fillRect l="-1149" t="-3509" b="-14035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3" name="Picture 2">
            <a:extLst>
              <a:ext uri="{FF2B5EF4-FFF2-40B4-BE49-F238E27FC236}">
                <a16:creationId xmlns:a16="http://schemas.microsoft.com/office/drawing/2014/main" id="{201CBC5E-0EE8-245C-B2C9-77EE6C682AA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18022" y="1473958"/>
            <a:ext cx="4982441" cy="3165482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9529D127-C4E2-A219-71DB-7819309A3CDE}"/>
                  </a:ext>
                </a:extLst>
              </p:cNvPr>
              <p:cNvSpPr txBox="1"/>
              <p:nvPr/>
            </p:nvSpPr>
            <p:spPr>
              <a:xfrm>
                <a:off x="718022" y="4842464"/>
                <a:ext cx="6580093" cy="10772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dian OS</a:t>
                </a:r>
              </a:p>
              <a:p>
                <a14:m>
                  <m:oMath xmlns:m="http://schemas.openxmlformats.org/officeDocument/2006/math">
                    <m:r>
                      <a:rPr lang="en-US" sz="16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≤ </m:t>
                    </m:r>
                  </m:oMath>
                </a14:m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 mg: 3.68 </a:t>
                </a:r>
                <a:r>
                  <a:rPr lang="en-US" sz="1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&gt;14 mg: 2.39 </a:t>
                </a:r>
                <a:r>
                  <a:rPr lang="en-US" sz="1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</a:t>
                </a:r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  <a:p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azard Ratio (</a:t>
                </a:r>
                <a14:m>
                  <m:oMath xmlns:m="http://schemas.openxmlformats.org/officeDocument/2006/math">
                    <m:r>
                      <a:rPr lang="en-US" sz="1600" i="1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≤</m:t>
                    </m:r>
                  </m:oMath>
                </a14:m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4 mg/ &gt;14 mg): 0.8635 (95% CI 0.448 to 1.66)</a:t>
                </a:r>
              </a:p>
            </p:txBody>
          </p:sp>
        </mc:Choice>
        <mc:Fallback xmlns=""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9529D127-C4E2-A219-71DB-7819309A3CDE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18022" y="4842464"/>
                <a:ext cx="6580093" cy="1077218"/>
              </a:xfrm>
              <a:prstGeom prst="rect">
                <a:avLst/>
              </a:prstGeom>
              <a:blipFill>
                <a:blip r:embed="rId7"/>
                <a:stretch>
                  <a:fillRect l="-578" t="-2326" b="-5814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9" name="Rectangle 1">
            <a:extLst>
              <a:ext uri="{FF2B5EF4-FFF2-40B4-BE49-F238E27FC236}">
                <a16:creationId xmlns:a16="http://schemas.microsoft.com/office/drawing/2014/main" id="{7D394ED1-BF11-4929-57C0-4394002376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1027" y="5956096"/>
            <a:ext cx="5494974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4a. Progression-free survival stratified by lenvatinib starting dose of ≤14 mg versus &gt;14 mg. </a:t>
            </a:r>
            <a:endParaRPr kumimoji="0" lang="en-US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5E32D66-42F9-F5BE-5CC6-64AC0BD7B420}"/>
              </a:ext>
            </a:extLst>
          </p:cNvPr>
          <p:cNvSpPr txBox="1"/>
          <p:nvPr/>
        </p:nvSpPr>
        <p:spPr>
          <a:xfrm>
            <a:off x="6418486" y="5975235"/>
            <a:ext cx="537371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US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4b. Progression-free survival stratified by lenvatinib starting dose of ≤20 mg versus &gt;20 mg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857091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20269CA-85CC-8783-2673-97BC44BE879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76AAC8-0C34-9DC0-4DFD-8E897AC057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-67269"/>
            <a:ext cx="10515600" cy="1325563"/>
          </a:xfrm>
        </p:spPr>
        <p:txBody>
          <a:bodyPr>
            <a:normAutofit/>
          </a:bodyPr>
          <a:lstStyle/>
          <a:p>
            <a:r>
              <a:rPr lang="en-US" sz="20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able S5. </a:t>
            </a:r>
            <a:r>
              <a:rPr lang="en-US" sz="2000" b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Multivariable logistical Cox regression analysis* 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BB75D84-319F-1376-328C-BF349BDB0BB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25593365"/>
              </p:ext>
            </p:extLst>
          </p:nvPr>
        </p:nvGraphicFramePr>
        <p:xfrm>
          <a:off x="1878842" y="1369756"/>
          <a:ext cx="8434316" cy="348266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958760">
                  <a:extLst>
                    <a:ext uri="{9D8B030D-6E8A-4147-A177-3AD203B41FA5}">
                      <a16:colId xmlns:a16="http://schemas.microsoft.com/office/drawing/2014/main" val="3167834269"/>
                    </a:ext>
                  </a:extLst>
                </a:gridCol>
                <a:gridCol w="1934256">
                  <a:extLst>
                    <a:ext uri="{9D8B030D-6E8A-4147-A177-3AD203B41FA5}">
                      <a16:colId xmlns:a16="http://schemas.microsoft.com/office/drawing/2014/main" val="1988084288"/>
                    </a:ext>
                  </a:extLst>
                </a:gridCol>
                <a:gridCol w="3041550">
                  <a:extLst>
                    <a:ext uri="{9D8B030D-6E8A-4147-A177-3AD203B41FA5}">
                      <a16:colId xmlns:a16="http://schemas.microsoft.com/office/drawing/2014/main" val="205614412"/>
                    </a:ext>
                  </a:extLst>
                </a:gridCol>
                <a:gridCol w="1499750">
                  <a:extLst>
                    <a:ext uri="{9D8B030D-6E8A-4147-A177-3AD203B41FA5}">
                      <a16:colId xmlns:a16="http://schemas.microsoft.com/office/drawing/2014/main" val="2561951591"/>
                    </a:ext>
                  </a:extLst>
                </a:gridCol>
              </a:tblGrid>
              <a:tr h="2592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Variable</a:t>
                      </a:r>
                      <a:endParaRPr lang="en-US" sz="16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Hazard Ratio</a:t>
                      </a:r>
                      <a:endParaRPr lang="en-US" sz="16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95% CI (profile likelihood)</a:t>
                      </a:r>
                      <a:endParaRPr lang="en-US" sz="16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P value</a:t>
                      </a:r>
                      <a:endParaRPr lang="en-US" sz="16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extLst>
                  <a:ext uri="{0D108BD9-81ED-4DB2-BD59-A6C34878D82A}">
                    <a16:rowId xmlns:a16="http://schemas.microsoft.com/office/drawing/2014/main" val="1082901261"/>
                  </a:ext>
                </a:extLst>
              </a:tr>
              <a:tr h="274597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1" u="none" strike="noStrike" dirty="0">
                          <a:effectLst/>
                        </a:rPr>
                        <a:t>Lenvatinib dose</a:t>
                      </a:r>
                      <a:endParaRPr lang="en-US" sz="16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effectLst/>
                        </a:rPr>
                        <a:t>1.020</a:t>
                      </a:r>
                      <a:endParaRPr lang="en-US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effectLst/>
                        </a:rPr>
                        <a:t>0.9479 to 1.097</a:t>
                      </a:r>
                      <a:endParaRPr lang="en-US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effectLst/>
                        </a:rPr>
                        <a:t>0.5985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extLst>
                  <a:ext uri="{0D108BD9-81ED-4DB2-BD59-A6C34878D82A}">
                    <a16:rowId xmlns:a16="http://schemas.microsoft.com/office/drawing/2014/main" val="207202560"/>
                  </a:ext>
                </a:extLst>
              </a:tr>
              <a:tr h="513331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1" u="none" strike="noStrike" dirty="0">
                          <a:effectLst/>
                        </a:rPr>
                        <a:t>Number of Prior Lines </a:t>
                      </a:r>
                      <a:endParaRPr lang="en-US" sz="16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effectLst/>
                        </a:rPr>
                        <a:t>0.9146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effectLst/>
                        </a:rPr>
                        <a:t>0.7103 to 1.113</a:t>
                      </a:r>
                      <a:endParaRPr lang="en-US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effectLst/>
                        </a:rPr>
                        <a:t>0.4300</a:t>
                      </a:r>
                      <a:endParaRPr lang="en-US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extLst>
                  <a:ext uri="{0D108BD9-81ED-4DB2-BD59-A6C34878D82A}">
                    <a16:rowId xmlns:a16="http://schemas.microsoft.com/office/drawing/2014/main" val="1476781739"/>
                  </a:ext>
                </a:extLst>
              </a:tr>
              <a:tr h="513331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1" u="none" strike="noStrike" dirty="0">
                          <a:effectLst/>
                        </a:rPr>
                        <a:t>Platinum-Resistant</a:t>
                      </a:r>
                      <a:endParaRPr lang="en-US" sz="16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effectLst/>
                        </a:rPr>
                        <a:t>2.074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effectLst/>
                        </a:rPr>
                        <a:t>0.9568 to 4.881</a:t>
                      </a:r>
                      <a:endParaRPr lang="en-US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effectLst/>
                        </a:rPr>
                        <a:t>0.0768</a:t>
                      </a:r>
                      <a:endParaRPr lang="en-US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extLst>
                  <a:ext uri="{0D108BD9-81ED-4DB2-BD59-A6C34878D82A}">
                    <a16:rowId xmlns:a16="http://schemas.microsoft.com/office/drawing/2014/main" val="3043116894"/>
                  </a:ext>
                </a:extLst>
              </a:tr>
              <a:tr h="274597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1" u="none" strike="noStrike" dirty="0">
                          <a:effectLst/>
                        </a:rPr>
                        <a:t>P53 Mutated</a:t>
                      </a:r>
                      <a:endParaRPr lang="en-US" sz="16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effectLst/>
                        </a:rPr>
                        <a:t>0.4590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effectLst/>
                        </a:rPr>
                        <a:t>0.2194 to 0.9847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effectLst/>
                        </a:rPr>
                        <a:t>0.0407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extLst>
                  <a:ext uri="{0D108BD9-81ED-4DB2-BD59-A6C34878D82A}">
                    <a16:rowId xmlns:a16="http://schemas.microsoft.com/office/drawing/2014/main" val="3866458664"/>
                  </a:ext>
                </a:extLst>
              </a:tr>
              <a:tr h="274597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1" u="none" strike="noStrike" dirty="0">
                          <a:effectLst/>
                        </a:rPr>
                        <a:t>Age (years)</a:t>
                      </a:r>
                      <a:endParaRPr lang="en-US" sz="16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effectLst/>
                        </a:rPr>
                        <a:t>0.9918</a:t>
                      </a:r>
                      <a:endParaRPr lang="en-US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effectLst/>
                        </a:rPr>
                        <a:t>0.9430 to 1.042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effectLst/>
                        </a:rPr>
                        <a:t>0.7456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extLst>
                  <a:ext uri="{0D108BD9-81ED-4DB2-BD59-A6C34878D82A}">
                    <a16:rowId xmlns:a16="http://schemas.microsoft.com/office/drawing/2014/main" val="1545321019"/>
                  </a:ext>
                </a:extLst>
              </a:tr>
              <a:tr h="274597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1" u="none" strike="noStrike" dirty="0">
                          <a:effectLst/>
                        </a:rPr>
                        <a:t>ECOG </a:t>
                      </a:r>
                      <a:r>
                        <a:rPr lang="en-US" sz="1600" b="1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 2</a:t>
                      </a:r>
                      <a:endParaRPr lang="en-US" sz="16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effectLst/>
                        </a:rPr>
                        <a:t>0.2981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effectLst/>
                        </a:rPr>
                        <a:t>0.1154 to 0.8149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effectLst/>
                        </a:rPr>
                        <a:t>0.0140</a:t>
                      </a:r>
                      <a:endParaRPr lang="en-US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extLst>
                  <a:ext uri="{0D108BD9-81ED-4DB2-BD59-A6C34878D82A}">
                    <a16:rowId xmlns:a16="http://schemas.microsoft.com/office/drawing/2014/main" val="585239918"/>
                  </a:ext>
                </a:extLst>
              </a:tr>
              <a:tr h="274597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1" i="0" u="none" strike="noStrike" dirty="0">
                          <a:effectLst/>
                          <a:latin typeface="Arial" panose="020B0604020202020204" pitchFamily="34" charset="0"/>
                        </a:rPr>
                        <a:t>BMI</a:t>
                      </a:r>
                    </a:p>
                  </a:txBody>
                  <a:tcPr marL="4923" marR="4923" marT="4923" marB="0" anchor="b"/>
                </a:tc>
                <a:tc gridSpan="3"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extLst>
                  <a:ext uri="{0D108BD9-81ED-4DB2-BD59-A6C34878D82A}">
                    <a16:rowId xmlns:a16="http://schemas.microsoft.com/office/drawing/2014/main" val="1213152010"/>
                  </a:ext>
                </a:extLst>
              </a:tr>
              <a:tr h="274597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u="none" strike="noStrike" dirty="0">
                          <a:effectLst/>
                        </a:rPr>
                        <a:t>Underweight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effectLst/>
                        </a:rPr>
                        <a:t>0.8637</a:t>
                      </a:r>
                      <a:endParaRPr lang="en-US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effectLst/>
                        </a:rPr>
                        <a:t>0.1278 to 3.492</a:t>
                      </a:r>
                      <a:endParaRPr lang="en-US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effectLst/>
                        </a:rPr>
                        <a:t>0.8552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extLst>
                  <a:ext uri="{0D108BD9-81ED-4DB2-BD59-A6C34878D82A}">
                    <a16:rowId xmlns:a16="http://schemas.microsoft.com/office/drawing/2014/main" val="255270816"/>
                  </a:ext>
                </a:extLst>
              </a:tr>
              <a:tr h="274597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u="none" strike="noStrike" dirty="0">
                          <a:effectLst/>
                        </a:rPr>
                        <a:t>Obese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effectLst/>
                        </a:rPr>
                        <a:t>0.8014</a:t>
                      </a:r>
                      <a:endParaRPr lang="en-US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effectLst/>
                        </a:rPr>
                        <a:t>0.3501 to 1.812</a:t>
                      </a:r>
                      <a:endParaRPr lang="en-US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effectLst/>
                        </a:rPr>
                        <a:t>0.5937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extLst>
                  <a:ext uri="{0D108BD9-81ED-4DB2-BD59-A6C34878D82A}">
                    <a16:rowId xmlns:a16="http://schemas.microsoft.com/office/drawing/2014/main" val="51144880"/>
                  </a:ext>
                </a:extLst>
              </a:tr>
              <a:tr h="274597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u="none" strike="noStrike" dirty="0">
                          <a:effectLst/>
                        </a:rPr>
                        <a:t>Overweight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effectLst/>
                        </a:rPr>
                        <a:t>1.533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>
                          <a:effectLst/>
                        </a:rPr>
                        <a:t>0.6353 to 3.684</a:t>
                      </a:r>
                      <a:endParaRPr lang="en-US" sz="1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effectLst/>
                        </a:rPr>
                        <a:t>0.3364</a:t>
                      </a:r>
                      <a:endParaRPr lang="en-US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923" marR="4923" marT="4923" marB="0" anchor="b"/>
                </a:tc>
                <a:extLst>
                  <a:ext uri="{0D108BD9-81ED-4DB2-BD59-A6C34878D82A}">
                    <a16:rowId xmlns:a16="http://schemas.microsoft.com/office/drawing/2014/main" val="3927863807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4B07EB6C-058F-434B-8362-2BE70298AA00}"/>
              </a:ext>
            </a:extLst>
          </p:cNvPr>
          <p:cNvSpPr txBox="1"/>
          <p:nvPr/>
        </p:nvSpPr>
        <p:spPr>
          <a:xfrm>
            <a:off x="1250867" y="5334355"/>
            <a:ext cx="9690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Lenvatinib starting dose was modeled as a continuous variable in the multivariable Cox proportional hazards model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C4A398E-52AD-79A4-E6EF-B7EF86E22D0A}"/>
              </a:ext>
            </a:extLst>
          </p:cNvPr>
          <p:cNvSpPr txBox="1"/>
          <p:nvPr/>
        </p:nvSpPr>
        <p:spPr>
          <a:xfrm>
            <a:off x="1250867" y="5816286"/>
            <a:ext cx="89389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5. Exploratory multivariable Cox proportional hazards model of factors associated with progression-free survival. </a:t>
            </a:r>
          </a:p>
        </p:txBody>
      </p:sp>
    </p:spTree>
    <p:extLst>
      <p:ext uri="{BB962C8B-B14F-4D97-AF65-F5344CB8AC3E}">
        <p14:creationId xmlns:p14="http://schemas.microsoft.com/office/powerpoint/2010/main" val="30739019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1B104F81-2AB0-C70F-CDCD-01F15119FF8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2512458"/>
              </p:ext>
            </p:extLst>
          </p:nvPr>
        </p:nvGraphicFramePr>
        <p:xfrm>
          <a:off x="1190975" y="76895"/>
          <a:ext cx="10090328" cy="63093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240316">
                  <a:extLst>
                    <a:ext uri="{9D8B030D-6E8A-4147-A177-3AD203B41FA5}">
                      <a16:colId xmlns:a16="http://schemas.microsoft.com/office/drawing/2014/main" val="2561290444"/>
                    </a:ext>
                  </a:extLst>
                </a:gridCol>
                <a:gridCol w="1494990">
                  <a:extLst>
                    <a:ext uri="{9D8B030D-6E8A-4147-A177-3AD203B41FA5}">
                      <a16:colId xmlns:a16="http://schemas.microsoft.com/office/drawing/2014/main" val="2364826678"/>
                    </a:ext>
                  </a:extLst>
                </a:gridCol>
                <a:gridCol w="950538">
                  <a:extLst>
                    <a:ext uri="{9D8B030D-6E8A-4147-A177-3AD203B41FA5}">
                      <a16:colId xmlns:a16="http://schemas.microsoft.com/office/drawing/2014/main" val="3061247674"/>
                    </a:ext>
                  </a:extLst>
                </a:gridCol>
                <a:gridCol w="950538">
                  <a:extLst>
                    <a:ext uri="{9D8B030D-6E8A-4147-A177-3AD203B41FA5}">
                      <a16:colId xmlns:a16="http://schemas.microsoft.com/office/drawing/2014/main" val="4124402238"/>
                    </a:ext>
                  </a:extLst>
                </a:gridCol>
                <a:gridCol w="950538">
                  <a:extLst>
                    <a:ext uri="{9D8B030D-6E8A-4147-A177-3AD203B41FA5}">
                      <a16:colId xmlns:a16="http://schemas.microsoft.com/office/drawing/2014/main" val="3958253456"/>
                    </a:ext>
                  </a:extLst>
                </a:gridCol>
                <a:gridCol w="950538">
                  <a:extLst>
                    <a:ext uri="{9D8B030D-6E8A-4147-A177-3AD203B41FA5}">
                      <a16:colId xmlns:a16="http://schemas.microsoft.com/office/drawing/2014/main" val="1385510544"/>
                    </a:ext>
                  </a:extLst>
                </a:gridCol>
                <a:gridCol w="950538">
                  <a:extLst>
                    <a:ext uri="{9D8B030D-6E8A-4147-A177-3AD203B41FA5}">
                      <a16:colId xmlns:a16="http://schemas.microsoft.com/office/drawing/2014/main" val="2982971250"/>
                    </a:ext>
                  </a:extLst>
                </a:gridCol>
                <a:gridCol w="691592">
                  <a:extLst>
                    <a:ext uri="{9D8B030D-6E8A-4147-A177-3AD203B41FA5}">
                      <a16:colId xmlns:a16="http://schemas.microsoft.com/office/drawing/2014/main" val="3056655972"/>
                    </a:ext>
                  </a:extLst>
                </a:gridCol>
                <a:gridCol w="910740">
                  <a:extLst>
                    <a:ext uri="{9D8B030D-6E8A-4147-A177-3AD203B41FA5}">
                      <a16:colId xmlns:a16="http://schemas.microsoft.com/office/drawing/2014/main" val="3463323555"/>
                    </a:ext>
                  </a:extLst>
                </a:gridCol>
              </a:tblGrid>
              <a:tr h="213540">
                <a:tc gridSpan="9"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ble S6. Lenvatinib Related Toxicity by Lenvatinib Starting Dose Subgroups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9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9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76998405"/>
                  </a:ext>
                </a:extLst>
              </a:tr>
              <a:tr h="213540">
                <a:tc gridSpan="4"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vatinib starting dose 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8710585"/>
                  </a:ext>
                </a:extLst>
              </a:tr>
              <a:tr h="346682"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erall (n=59)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10 mg (n=31)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vatinib starting dose &lt;/= 10 mg (n=28)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91913098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xicity End Poi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23114554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ertens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57175602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tigu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65453161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rrhe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4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6092643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orexi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4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57609142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use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236708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8259025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sh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76453255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cosit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73483377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-F Syndro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99197267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stul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17286797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46228560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dach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2689869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uri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60943404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72930151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oice changes/ hoarsenes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06214455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levated </a:t>
                      </a:r>
                      <a:r>
                        <a:rPr lang="en-US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r</a:t>
                      </a:r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26116202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asons </a:t>
                      </a:r>
                      <a:r>
                        <a:rPr lang="en-US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 Treatment </a:t>
                      </a:r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ntinuation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53279491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gression of Disea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7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9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23175974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vatinib Toxic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6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8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7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9396127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mbrolizumab Toxic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6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5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4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05770761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ath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9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9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02554749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v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5373927"/>
                  </a:ext>
                </a:extLst>
              </a:tr>
              <a:tr h="213540"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main on Therap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2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9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1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24702145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A1640D29-2449-8BDF-C6E4-02FCC8A2E244}"/>
              </a:ext>
            </a:extLst>
          </p:cNvPr>
          <p:cNvSpPr txBox="1"/>
          <p:nvPr/>
        </p:nvSpPr>
        <p:spPr>
          <a:xfrm>
            <a:off x="1959138" y="6550273"/>
            <a:ext cx="5606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6. Treatment-related toxicities and reasons for discontinuation according to lenvatinib starting dose subgroup.</a:t>
            </a:r>
          </a:p>
        </p:txBody>
      </p:sp>
    </p:spTree>
    <p:extLst>
      <p:ext uri="{BB962C8B-B14F-4D97-AF65-F5344CB8AC3E}">
        <p14:creationId xmlns:p14="http://schemas.microsoft.com/office/powerpoint/2010/main" val="9940377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9</TotalTime>
  <Words>897</Words>
  <Application>Microsoft Macintosh PowerPoint</Application>
  <PresentationFormat>Widescreen</PresentationFormat>
  <Paragraphs>320</Paragraphs>
  <Slides>6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ptos</vt:lpstr>
      <vt:lpstr>Aptos Display</vt:lpstr>
      <vt:lpstr>Arial</vt:lpstr>
      <vt:lpstr>Cambria Math</vt:lpstr>
      <vt:lpstr>Times New Roman</vt:lpstr>
      <vt:lpstr>Office Theme</vt:lpstr>
      <vt:lpstr>PowerPoint Presentation</vt:lpstr>
      <vt:lpstr>PowerPoint Presentation</vt:lpstr>
      <vt:lpstr>Figure S3: Non-inferiority test between the ≤  10 mg and &gt; 10 mg dose groups</vt:lpstr>
      <vt:lpstr>PowerPoint Presentation</vt:lpstr>
      <vt:lpstr>Table S5. Multivariable logistical Cox regression analysis* 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smin Abozenah</dc:creator>
  <cp:lastModifiedBy>Altwerger, Gary [BSD]</cp:lastModifiedBy>
  <cp:revision>22</cp:revision>
  <dcterms:created xsi:type="dcterms:W3CDTF">2025-09-13T19:31:46Z</dcterms:created>
  <dcterms:modified xsi:type="dcterms:W3CDTF">2026-04-25T09:28:53Z</dcterms:modified>
</cp:coreProperties>
</file>